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1" r:id="rId5"/>
    <p:sldId id="257" r:id="rId6"/>
    <p:sldId id="265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29" userDrawn="1">
          <p15:clr>
            <a:srgbClr val="A4A3A4"/>
          </p15:clr>
        </p15:guide>
        <p15:guide id="2" pos="23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1792" y="176"/>
      </p:cViewPr>
      <p:guideLst>
        <p:guide orient="horz" pos="1729"/>
        <p:guide pos="2336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698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2344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644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695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16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5671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46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5510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1788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568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9476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1E82C-F96E-4F2D-9382-643BAFE14515}" type="datetimeFigureOut">
              <a:rPr lang="en-GB" smtClean="0"/>
              <a:t>20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C558F8-3019-43B7-B8BD-BD51B9804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7642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"/><Relationship Id="rId3" Type="http://schemas.openxmlformats.org/officeDocument/2006/relationships/image" Target="../media/image4.tif"/><Relationship Id="rId7" Type="http://schemas.openxmlformats.org/officeDocument/2006/relationships/image" Target="../media/image8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"/><Relationship Id="rId11" Type="http://schemas.openxmlformats.org/officeDocument/2006/relationships/image" Target="../media/image12.tif"/><Relationship Id="rId5" Type="http://schemas.openxmlformats.org/officeDocument/2006/relationships/image" Target="../media/image6.tif"/><Relationship Id="rId10" Type="http://schemas.openxmlformats.org/officeDocument/2006/relationships/image" Target="../media/image11.tif"/><Relationship Id="rId4" Type="http://schemas.openxmlformats.org/officeDocument/2006/relationships/image" Target="../media/image5.tif"/><Relationship Id="rId9" Type="http://schemas.openxmlformats.org/officeDocument/2006/relationships/image" Target="../media/image10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64579" y="6027004"/>
            <a:ext cx="81980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upplementary Figure 1:  The method used to analyse the ON and OFF rate of NV centres during blinking. The image shows the areas sampled (scale bar 2 µm) and the graph shows the PL intensity of the area over frames and the threshold used. </a:t>
            </a:r>
          </a:p>
        </p:txBody>
      </p:sp>
      <p:grpSp>
        <p:nvGrpSpPr>
          <p:cNvPr id="37" name="Group 36"/>
          <p:cNvGrpSpPr/>
          <p:nvPr/>
        </p:nvGrpSpPr>
        <p:grpSpPr>
          <a:xfrm>
            <a:off x="2131425" y="104398"/>
            <a:ext cx="4881150" cy="5730444"/>
            <a:chOff x="2131425" y="104398"/>
            <a:chExt cx="4881150" cy="573044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344"/>
            <a:stretch/>
          </p:blipFill>
          <p:spPr>
            <a:xfrm>
              <a:off x="2131425" y="3265821"/>
              <a:ext cx="4881150" cy="2569021"/>
            </a:xfrm>
            <a:prstGeom prst="rect">
              <a:avLst/>
            </a:prstGeom>
          </p:spPr>
        </p:pic>
        <p:grpSp>
          <p:nvGrpSpPr>
            <p:cNvPr id="28" name="Group 27"/>
            <p:cNvGrpSpPr/>
            <p:nvPr/>
          </p:nvGrpSpPr>
          <p:grpSpPr>
            <a:xfrm>
              <a:off x="2805113" y="104398"/>
              <a:ext cx="3533775" cy="2962275"/>
              <a:chOff x="137983" y="409198"/>
              <a:chExt cx="3533775" cy="2962275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7983" y="409198"/>
                <a:ext cx="3533775" cy="2962275"/>
              </a:xfrm>
              <a:prstGeom prst="rect">
                <a:avLst/>
              </a:prstGeom>
            </p:spPr>
          </p:pic>
          <p:sp>
            <p:nvSpPr>
              <p:cNvPr id="3" name="Oval 2"/>
              <p:cNvSpPr/>
              <p:nvPr/>
            </p:nvSpPr>
            <p:spPr>
              <a:xfrm>
                <a:off x="2115296" y="1050332"/>
                <a:ext cx="324000" cy="324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7" name="Oval 6"/>
              <p:cNvSpPr/>
              <p:nvPr/>
            </p:nvSpPr>
            <p:spPr>
              <a:xfrm>
                <a:off x="2198911" y="1533638"/>
                <a:ext cx="396000" cy="39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8" name="Oval 7"/>
              <p:cNvSpPr/>
              <p:nvPr/>
            </p:nvSpPr>
            <p:spPr>
              <a:xfrm>
                <a:off x="1512861" y="1552511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1" name="Oval 10"/>
              <p:cNvSpPr/>
              <p:nvPr/>
            </p:nvSpPr>
            <p:spPr>
              <a:xfrm>
                <a:off x="1105607" y="1399511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2" name="Oval 11"/>
              <p:cNvSpPr/>
              <p:nvPr/>
            </p:nvSpPr>
            <p:spPr>
              <a:xfrm>
                <a:off x="1383681" y="878837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3" name="Oval 12"/>
              <p:cNvSpPr/>
              <p:nvPr/>
            </p:nvSpPr>
            <p:spPr>
              <a:xfrm>
                <a:off x="1770838" y="814004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4" name="Oval 13"/>
              <p:cNvSpPr/>
              <p:nvPr/>
            </p:nvSpPr>
            <p:spPr>
              <a:xfrm>
                <a:off x="1702886" y="1236433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5" name="Oval 14"/>
              <p:cNvSpPr/>
              <p:nvPr/>
            </p:nvSpPr>
            <p:spPr>
              <a:xfrm>
                <a:off x="2608354" y="1413264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6" name="Oval 15"/>
              <p:cNvSpPr/>
              <p:nvPr/>
            </p:nvSpPr>
            <p:spPr>
              <a:xfrm>
                <a:off x="1949209" y="2291578"/>
                <a:ext cx="306000" cy="306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7" name="Oval 16"/>
              <p:cNvSpPr/>
              <p:nvPr/>
            </p:nvSpPr>
            <p:spPr>
              <a:xfrm>
                <a:off x="2208516" y="1949190"/>
                <a:ext cx="288000" cy="288000"/>
              </a:xfrm>
              <a:prstGeom prst="ellipse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5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212624" y="1923063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2</a:t>
                </a:r>
                <a:endParaRPr lang="en-GB" sz="2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341440" y="858501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10</a:t>
                </a:r>
                <a:endParaRPr lang="en-GB" sz="2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968780" y="2271407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3</a:t>
                </a:r>
                <a:endParaRPr lang="en-GB" sz="2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256169" y="1566015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8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617579" y="138748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5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129891" y="1039147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4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781550" y="795306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7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711881" y="121331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1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119696" y="1370069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6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520291" y="1518116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b="1" dirty="0">
                    <a:solidFill>
                      <a:schemeClr val="bg1"/>
                    </a:solidFill>
                  </a:rPr>
                  <a:t>9</a:t>
                </a:r>
              </a:p>
            </p:txBody>
          </p:sp>
        </p:grpSp>
        <p:cxnSp>
          <p:nvCxnSpPr>
            <p:cNvPr id="32" name="Straight Connector 31"/>
            <p:cNvCxnSpPr/>
            <p:nvPr/>
          </p:nvCxnSpPr>
          <p:spPr>
            <a:xfrm>
              <a:off x="4485991" y="1374584"/>
              <a:ext cx="1540340" cy="1899946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 flipH="1">
              <a:off x="2952206" y="1482198"/>
              <a:ext cx="1260000" cy="1800000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86527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51113" y="6528520"/>
            <a:ext cx="69375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upplementary Figure 2:  On and off time histograms (all on the same x axis)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063" y="3970356"/>
            <a:ext cx="1674000" cy="12555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063" y="5261558"/>
            <a:ext cx="1674000" cy="12555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063" y="1387952"/>
            <a:ext cx="1674000" cy="12555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063" y="96750"/>
            <a:ext cx="1674000" cy="12555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063" y="2679154"/>
            <a:ext cx="1674000" cy="12555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938" y="3970356"/>
            <a:ext cx="1674000" cy="12555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938" y="2679154"/>
            <a:ext cx="1674000" cy="12555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938" y="5261558"/>
            <a:ext cx="1674000" cy="12555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938" y="1387952"/>
            <a:ext cx="1674000" cy="12555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938" y="96750"/>
            <a:ext cx="1674000" cy="125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49368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63676"/>
            <a:ext cx="2996784" cy="216039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6108" y="1663677"/>
            <a:ext cx="3306515" cy="203496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2623" y="1663676"/>
            <a:ext cx="2759169" cy="218988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18961" y="4991222"/>
            <a:ext cx="819806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upplementary Figure 3: (a) Histogram of the photon count in a single event (b) Histogram of the photon count for a sandstorm event (green) and low background photons (grey). Inset shows an enlarged scale of the background photons. (c) Histogram of the photon count for </a:t>
            </a:r>
            <a:r>
              <a:rPr lang="en-GB" sz="1600" dirty="0" err="1"/>
              <a:t>dSTORM</a:t>
            </a:r>
            <a:r>
              <a:rPr lang="en-GB" sz="1600" dirty="0"/>
              <a:t> (purple) with high background photons (grey).</a:t>
            </a:r>
          </a:p>
          <a:p>
            <a:endParaRPr lang="en-GB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200792" y="1007292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(a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60842" y="100729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(b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411624" y="1007324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790387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7C6FD6A2F56034BB034DA031AECA341" ma:contentTypeVersion="13" ma:contentTypeDescription="Create a new document." ma:contentTypeScope="" ma:versionID="a3ad6c6e3c31cedd295dfc501073a691">
  <xsd:schema xmlns:xsd="http://www.w3.org/2001/XMLSchema" xmlns:xs="http://www.w3.org/2001/XMLSchema" xmlns:p="http://schemas.microsoft.com/office/2006/metadata/properties" xmlns:ns3="93b69053-3eb3-4002-bc01-da437c313fd2" xmlns:ns4="4ab0fe88-2856-48fc-928d-45b76abe8174" targetNamespace="http://schemas.microsoft.com/office/2006/metadata/properties" ma:root="true" ma:fieldsID="720590917fd9c62b65ba0b9882832791" ns3:_="" ns4:_="">
    <xsd:import namespace="93b69053-3eb3-4002-bc01-da437c313fd2"/>
    <xsd:import namespace="4ab0fe88-2856-48fc-928d-45b76abe817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3b69053-3eb3-4002-bc01-da437c313fd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b0fe88-2856-48fc-928d-45b76abe8174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C56A297-ADBF-4220-8230-323E17503A6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454F658-51C9-451F-883A-A3A29903291A}">
  <ds:schemaRefs>
    <ds:schemaRef ds:uri="93b69053-3eb3-4002-bc01-da437c313fd2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4ab0fe88-2856-48fc-928d-45b76abe8174"/>
    <ds:schemaRef ds:uri="http://purl.org/dc/terms/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51FAD496-ED4C-47FD-998D-FD2421956AA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3b69053-3eb3-4002-bc01-da437c313fd2"/>
    <ds:schemaRef ds:uri="4ab0fe88-2856-48fc-928d-45b76abe817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17</TotalTime>
  <Words>153</Words>
  <Application>Microsoft Macintosh PowerPoint</Application>
  <PresentationFormat>On-screen Show (4:3)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Mather</dc:creator>
  <cp:lastModifiedBy>Izzy Jayasinghe</cp:lastModifiedBy>
  <cp:revision>60</cp:revision>
  <dcterms:created xsi:type="dcterms:W3CDTF">2020-03-18T12:35:08Z</dcterms:created>
  <dcterms:modified xsi:type="dcterms:W3CDTF">2020-05-20T17:14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7C6FD6A2F56034BB034DA031AECA341</vt:lpwstr>
  </property>
</Properties>
</file>